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030"/>
    <p:restoredTop sz="94704"/>
  </p:normalViewPr>
  <p:slideViewPr>
    <p:cSldViewPr snapToGrid="0">
      <p:cViewPr>
        <p:scale>
          <a:sx n="134" d="100"/>
          <a:sy n="134" d="100"/>
        </p:scale>
        <p:origin x="352" y="9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29EAD8-4E37-704D-861F-1315FBEDCB18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58F96C-1B4F-A44D-B6C5-B96289C43E4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1629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58F96C-1B4F-A44D-B6C5-B96289C43E4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78322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2CB0A2-9393-B752-D1A0-3A7AAAD42C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C47F0B-5B11-D81E-ED2D-B61E823921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7C87F6-B66E-E348-7384-2819E0C125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F88462-C95E-3871-DD5B-59E8BB897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56065D-3DC1-1121-9378-C6DC8FE26B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8148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745DFC-5DB9-12AB-EEF0-49631FA411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D7C08D2-5BFA-E422-7816-17F00B007D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D54FAA-8B78-3BEF-C583-B1BEB9136B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7B83A6-6BAC-3451-B337-1EF2C6D9D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DAAF6F-0738-73A6-A504-7476E73F5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8347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4FD2B3-1DCA-54C1-A832-0870E1CA70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53496D-5B00-AD37-EABF-693F7D536D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F6BBA9-BC9F-B0E6-0C51-B816ECD3C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7FA25F-3482-D96E-53A1-BC8E1BD05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B0809A-F47F-9EDA-907C-F3939CEB0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8117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B0EEC6-5410-2DE8-3FCB-DD6310FFB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F452B1-2759-8A2B-1AF7-E3C24536B7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222CBB-6554-E926-9948-CDEC10661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14A865-D7E5-A3DF-A92D-43BB31DBD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635A91-DE70-3BD5-ED33-5E2965BF7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333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2648AA-C5C3-DC93-61DF-BF62C02E1C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8C912D-7A4B-2C8F-9D7B-F7E65555FC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418771-C30F-B93C-A775-14773CDA4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A74E96-1759-4B38-1EF1-9FC0BC5F6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4CA8C2-A37B-808C-7BA8-9B3C647A9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1873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3E6CEA-2464-8B25-A6A8-A7CCE0E098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F4E2FF-125D-9302-8BCD-DD69CEA3FA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F3D3BA4-BBD9-A3E3-FFC9-EFFA61AFA1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6A0B18-C9E8-9EDE-F7D8-6B1FF2408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62A6CA-4246-943B-9EA8-F7E2FC727A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C27D23-01A6-1928-58A5-ED53F57C5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6337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F121A-DB84-87F6-7257-69F9BADFFD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7427D62-DD70-9240-1976-71680DE6C5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B78638-D7DF-0518-2942-E5A842BD32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158A59-C3D8-AEE4-2ED8-E8185A464B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B2EBC6-68FF-4599-4E07-268C36E12E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4A6B6A5-8331-1B63-0656-2F1D7DD24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428A23-A795-B7C0-4BEC-0211AA22B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527CF0-9E22-A6A8-8C6A-E14D3830B9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8321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2C4019-7EFE-610F-47B1-4C357EDB11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B103BFB-4975-6376-9BF1-BF4FBED84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6E7D35-9D45-8816-EC59-720E210F8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44E4EEF-E15A-71C5-15B1-34441F0EA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7798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899089-F1BE-76A0-9600-DCD6204AD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8B77165-7251-24FD-BF93-332E2B850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5E51267-0447-D230-BE48-26EADD817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165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4F2CBA-56C3-7717-FE20-4194E8C22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AF0539-F23E-105D-9E57-6CAF1705F6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36E35D-3196-7D2A-4371-DE77DDBCCB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8AE790-B989-D4E6-1150-C8C41B0D9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46FA12-54E2-01DA-F72B-A8BEF4E157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7828B6-E612-6B05-080F-E005126BE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53050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187F5A-143F-78D9-4012-3CA03DBF60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3164772-7CB1-3B58-37C9-E32320BAE5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21BD2E-6809-C013-3071-89DCC800EE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2C5DCF-294A-F1D0-E151-00431D39E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5EF866-05D6-9A63-8C88-6D2391901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752C95-729E-6C49-0E7D-86EABD6E6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3864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70E1C03-C96D-795A-4698-73A4E709B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93FA8D-33D8-1D80-4630-5E6A394A44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EAFBEF-E3B3-CA69-A3C5-677D30ED5F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2A00C3-DC2A-594F-AEA6-3D9449985FEB}" type="datetimeFigureOut">
              <a:rPr lang="en-GB" smtClean="0"/>
              <a:t>16/08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699DB8-D790-99D0-78E2-8BB2CD23A9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6D5B9E-9F84-2525-5E2F-F6A86DAD29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18F52DC-9885-7343-8A79-D5FDF6A3AF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185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3D4AED4-2951-DCE8-9E40-192F019A00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5715869"/>
              </p:ext>
            </p:extLst>
          </p:nvPr>
        </p:nvGraphicFramePr>
        <p:xfrm>
          <a:off x="825500" y="2300135"/>
          <a:ext cx="10541000" cy="1745677"/>
        </p:xfrm>
        <a:graphic>
          <a:graphicData uri="http://schemas.openxmlformats.org/drawingml/2006/table">
            <a:tbl>
              <a:tblPr/>
              <a:tblGrid>
                <a:gridCol w="3600279">
                  <a:extLst>
                    <a:ext uri="{9D8B030D-6E8A-4147-A177-3AD203B41FA5}">
                      <a16:colId xmlns:a16="http://schemas.microsoft.com/office/drawing/2014/main" val="4219870929"/>
                    </a:ext>
                  </a:extLst>
                </a:gridCol>
                <a:gridCol w="1016476">
                  <a:extLst>
                    <a:ext uri="{9D8B030D-6E8A-4147-A177-3AD203B41FA5}">
                      <a16:colId xmlns:a16="http://schemas.microsoft.com/office/drawing/2014/main" val="2834742446"/>
                    </a:ext>
                  </a:extLst>
                </a:gridCol>
                <a:gridCol w="168373">
                  <a:extLst>
                    <a:ext uri="{9D8B030D-6E8A-4147-A177-3AD203B41FA5}">
                      <a16:colId xmlns:a16="http://schemas.microsoft.com/office/drawing/2014/main" val="2236808108"/>
                    </a:ext>
                  </a:extLst>
                </a:gridCol>
                <a:gridCol w="1016476">
                  <a:extLst>
                    <a:ext uri="{9D8B030D-6E8A-4147-A177-3AD203B41FA5}">
                      <a16:colId xmlns:a16="http://schemas.microsoft.com/office/drawing/2014/main" val="1642886342"/>
                    </a:ext>
                  </a:extLst>
                </a:gridCol>
                <a:gridCol w="168373">
                  <a:extLst>
                    <a:ext uri="{9D8B030D-6E8A-4147-A177-3AD203B41FA5}">
                      <a16:colId xmlns:a16="http://schemas.microsoft.com/office/drawing/2014/main" val="986902383"/>
                    </a:ext>
                  </a:extLst>
                </a:gridCol>
                <a:gridCol w="1016476">
                  <a:extLst>
                    <a:ext uri="{9D8B030D-6E8A-4147-A177-3AD203B41FA5}">
                      <a16:colId xmlns:a16="http://schemas.microsoft.com/office/drawing/2014/main" val="1812689926"/>
                    </a:ext>
                  </a:extLst>
                </a:gridCol>
                <a:gridCol w="168373">
                  <a:extLst>
                    <a:ext uri="{9D8B030D-6E8A-4147-A177-3AD203B41FA5}">
                      <a16:colId xmlns:a16="http://schemas.microsoft.com/office/drawing/2014/main" val="2769422093"/>
                    </a:ext>
                  </a:extLst>
                </a:gridCol>
                <a:gridCol w="1016476">
                  <a:extLst>
                    <a:ext uri="{9D8B030D-6E8A-4147-A177-3AD203B41FA5}">
                      <a16:colId xmlns:a16="http://schemas.microsoft.com/office/drawing/2014/main" val="3161570405"/>
                    </a:ext>
                  </a:extLst>
                </a:gridCol>
                <a:gridCol w="168373">
                  <a:extLst>
                    <a:ext uri="{9D8B030D-6E8A-4147-A177-3AD203B41FA5}">
                      <a16:colId xmlns:a16="http://schemas.microsoft.com/office/drawing/2014/main" val="176813767"/>
                    </a:ext>
                  </a:extLst>
                </a:gridCol>
                <a:gridCol w="1016476">
                  <a:extLst>
                    <a:ext uri="{9D8B030D-6E8A-4147-A177-3AD203B41FA5}">
                      <a16:colId xmlns:a16="http://schemas.microsoft.com/office/drawing/2014/main" val="3242762986"/>
                    </a:ext>
                  </a:extLst>
                </a:gridCol>
                <a:gridCol w="168373">
                  <a:extLst>
                    <a:ext uri="{9D8B030D-6E8A-4147-A177-3AD203B41FA5}">
                      <a16:colId xmlns:a16="http://schemas.microsoft.com/office/drawing/2014/main" val="2733075504"/>
                    </a:ext>
                  </a:extLst>
                </a:gridCol>
                <a:gridCol w="1016476">
                  <a:extLst>
                    <a:ext uri="{9D8B030D-6E8A-4147-A177-3AD203B41FA5}">
                      <a16:colId xmlns:a16="http://schemas.microsoft.com/office/drawing/2014/main" val="1692386693"/>
                    </a:ext>
                  </a:extLst>
                </a:gridCol>
              </a:tblGrid>
              <a:tr h="133004">
                <a:tc>
                  <a:txBody>
                    <a:bodyPr/>
                    <a:lstStyle/>
                    <a:p>
                      <a:pPr algn="l" fontAlgn="b"/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0059037"/>
                  </a:ext>
                </a:extLst>
              </a:tr>
              <a:tr h="133004"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7766972"/>
                  </a:ext>
                </a:extLst>
              </a:tr>
              <a:tr h="133004">
                <a:tc gridSpan="12"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dditional file 2. 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stimates from logistic regression models examining children's exposure to sugary beverage advertisements </a:t>
                      </a:r>
                      <a:r>
                        <a:rPr lang="en-GB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t least weekly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by location of school classes during the COVID-19 pandemic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3102754"/>
                  </a:ext>
                </a:extLst>
              </a:tr>
              <a:tr h="282633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rameter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ustralia</a:t>
                      </a:r>
                      <a:b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n=2078)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nada</a:t>
                      </a:r>
                      <a:b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n=5924)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ile</a:t>
                      </a:r>
                      <a:b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n=2465)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xico</a:t>
                      </a:r>
                      <a:b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n=3127)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nited Kingdom</a:t>
                      </a:r>
                      <a:b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n=2576)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United States</a:t>
                      </a:r>
                      <a:b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n=2985)</a:t>
                      </a:r>
                    </a:p>
                  </a:txBody>
                  <a:tcPr marL="6235" marR="6235" marT="623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5820470"/>
                  </a:ext>
                </a:extLst>
              </a:tr>
              <a:tr h="13300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OR (99% CI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OR (99% CI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OR (99% CI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OR (99% CI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OR (99% CI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 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OR (99% CI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8411010"/>
                  </a:ext>
                </a:extLst>
              </a:tr>
              <a:tr h="13300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Location of school classes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1318687"/>
                  </a:ext>
                </a:extLst>
              </a:tr>
              <a:tr h="13300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l classes online/from home vs some classes at school, some classes online/from home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90 (1.11, 3.23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77 (0.61, 0.97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39 (0.88, 2.19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99 (0.58, 1.70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26 (0.76, 2.09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82 (0.56, 1.22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5578376"/>
                  </a:ext>
                </a:extLst>
              </a:tr>
              <a:tr h="13300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ll classes online/from home vs all classes at school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98 (1.27, 3.09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00 (0.82, 1.21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07 (0.51, 2.25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80 (0.35, 1.80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64 (1.04, 2.57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03 (0.72, 1.47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16648573"/>
                  </a:ext>
                </a:extLst>
              </a:tr>
              <a:tr h="133004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ome classes at school, some classes online/from home vs all classes at school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05 (0.73, 1.50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30 (1.07, 1.56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77 (0.38, 1.59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.80 (0.35, 1.83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30 (0.97, 1.75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.25 (0.85, 1.83)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10795298"/>
                  </a:ext>
                </a:extLst>
              </a:tr>
              <a:tr h="133004">
                <a:tc gridSpan="12">
                  <a:txBody>
                    <a:bodyPr/>
                    <a:lstStyle/>
                    <a:p>
                      <a:pPr algn="l" fontAlgn="t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bbreviations</a:t>
                      </a:r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: AOR = Adjusted odds ratio, CI = confidence interval.</a:t>
                      </a:r>
                    </a:p>
                  </a:txBody>
                  <a:tcPr marL="6235" marR="6235" marT="623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7783186"/>
                  </a:ext>
                </a:extLst>
              </a:tr>
              <a:tr h="133004">
                <a:tc gridSpan="12"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odels were adjusted for: year, sex, age category, ethnicity, perceived income adequacy and total screen time.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80756487"/>
                  </a:ext>
                </a:extLst>
              </a:tr>
              <a:tr h="133004">
                <a:tc gridSpan="12">
                  <a:txBody>
                    <a:bodyPr/>
                    <a:lstStyle/>
                    <a:p>
                      <a:pPr algn="l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es</a:t>
                      </a:r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: The location of school classes listed second is the reference variable (n=19 155).</a:t>
                      </a:r>
                    </a:p>
                  </a:txBody>
                  <a:tcPr marL="6235" marR="6235" marT="623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776473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22841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32</Words>
  <Application>Microsoft Macintosh PowerPoint</Application>
  <PresentationFormat>Widescreen</PresentationFormat>
  <Paragraphs>5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Élisabeth Demers-Potvin</dc:creator>
  <cp:lastModifiedBy>Élisabeth Demers-Potvin</cp:lastModifiedBy>
  <cp:revision>1</cp:revision>
  <dcterms:created xsi:type="dcterms:W3CDTF">2024-08-16T16:44:42Z</dcterms:created>
  <dcterms:modified xsi:type="dcterms:W3CDTF">2024-08-16T16:45:56Z</dcterms:modified>
</cp:coreProperties>
</file>